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B0C2F-E1FD-465F-BF9C-1A6E6F29B7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61D41E-4819-4BB7-924E-D6F1953644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FBA34-21C0-4F13-A60D-281C07D948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0E90A-106B-41C5-AF0C-AF0A21B9F0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75CF1-B87F-458E-A2CE-7319259EA2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DF38A-AB68-46C2-A877-F4AF03CE77E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91FA8-A014-4747-916F-59293213E6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20A2C0-99C5-4646-899F-61F1A9C13A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9B1592-873C-48D4-97D6-D873DD28F7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4434F-EBD8-48CE-B755-E71D88CF6A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55D0EA-8F7D-4590-8C27-970BC7B76B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543A6-3ABE-4FF6-A268-C33A044804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4D7A32-49E3-4140-B17E-4135B4ADA7B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image" Target="../media/image1.png"/><Relationship Id="rId4" Type="http://schemas.openxmlformats.org/officeDocument/2006/relationships/image" Target="../media/image1.png"/><Relationship Id="rId5" Type="http://schemas.openxmlformats.org/officeDocument/2006/relationships/image" Target="../media/image1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60680" y="828720"/>
            <a:ext cx="5736600" cy="3016800"/>
            <a:chOff x="760680" y="828720"/>
            <a:chExt cx="5736600" cy="3016800"/>
          </a:xfrm>
        </p:grpSpPr>
        <p:sp>
          <p:nvSpPr>
            <p:cNvPr id="42" name=""/>
            <p:cNvSpPr/>
            <p:nvPr/>
          </p:nvSpPr>
          <p:spPr>
            <a:xfrm>
              <a:off x="1119240" y="3070440"/>
              <a:ext cx="38764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119240" y="2527560"/>
              <a:ext cx="38764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119240" y="1984680"/>
              <a:ext cx="38764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119240" y="1443240"/>
              <a:ext cx="38764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119240" y="900360"/>
              <a:ext cx="3876480" cy="14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117440" y="898560"/>
              <a:ext cx="3876840" cy="2713320"/>
            </a:xfrm>
            <a:prstGeom prst="rect">
              <a:avLst/>
            </a:prstGeom>
            <a:noFill/>
            <a:ln w="32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496880" y="2652840"/>
              <a:ext cx="7920" cy="9604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465280" y="3019680"/>
              <a:ext cx="7920" cy="593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433680" y="3300480"/>
              <a:ext cx="7920" cy="31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679840" y="2183040"/>
              <a:ext cx="7920" cy="1430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289160" y="2644920"/>
              <a:ext cx="215640" cy="9684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257560" y="3013200"/>
              <a:ext cx="215640" cy="600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227400" y="3292560"/>
              <a:ext cx="214200" cy="320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187880" y="3316320"/>
              <a:ext cx="215640" cy="297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504800" y="1409760"/>
              <a:ext cx="214560" cy="22035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473200" y="2176560"/>
              <a:ext cx="214560" cy="14367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441600" y="2978280"/>
              <a:ext cx="216000" cy="6350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403520" y="3214800"/>
              <a:ext cx="214560" cy="398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719360" y="3029040"/>
              <a:ext cx="215640" cy="58428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687760" y="3256200"/>
              <a:ext cx="215640" cy="357120"/>
            </a:xfrm>
            <a:prstGeom prst="rect">
              <a:avLst/>
            </a:prstGeom>
            <a:blipFill rotWithShape="0">
              <a:blip r:embed="rId2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657600" y="3346560"/>
              <a:ext cx="214200" cy="266760"/>
            </a:xfrm>
            <a:prstGeom prst="rect">
              <a:avLst/>
            </a:prstGeom>
            <a:blipFill rotWithShape="0">
              <a:blip r:embed="rId3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618080" y="3333960"/>
              <a:ext cx="215640" cy="279360"/>
            </a:xfrm>
            <a:prstGeom prst="rect">
              <a:avLst/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119240" y="900360"/>
              <a:ext cx="1440" cy="2712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084320" y="3613320"/>
              <a:ext cx="34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084320" y="3070440"/>
              <a:ext cx="34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084320" y="2527560"/>
              <a:ext cx="34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084320" y="1984680"/>
              <a:ext cx="34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084320" y="1443240"/>
              <a:ext cx="34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084320" y="900360"/>
              <a:ext cx="3492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119240" y="3613320"/>
              <a:ext cx="387648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1119240" y="3612960"/>
              <a:ext cx="1440" cy="36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2089080" y="3612960"/>
              <a:ext cx="1440" cy="36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3057480" y="3612960"/>
              <a:ext cx="1440" cy="36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4025880" y="3612960"/>
              <a:ext cx="1440" cy="36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4995720" y="3612960"/>
              <a:ext cx="1800" cy="363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034280" y="3542040"/>
              <a:ext cx="64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829080" y="2998800"/>
              <a:ext cx="25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5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760680" y="245772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760680" y="191484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5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760680" y="137160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760680" y="828720"/>
              <a:ext cx="3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5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318320" y="3569040"/>
              <a:ext cx="60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ATA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220480" y="3569040"/>
              <a:ext cx="73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ATA-1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184200" y="3569040"/>
              <a:ext cx="730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ATA-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053960" y="3569040"/>
              <a:ext cx="88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TATA-less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106960" y="1990800"/>
              <a:ext cx="69840" cy="730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200920" y="1951200"/>
              <a:ext cx="1096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Median maximum all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106960" y="2138400"/>
              <a:ext cx="69840" cy="730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199480" y="2098800"/>
              <a:ext cx="1297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Median maximum &lt;8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5106960" y="2286000"/>
              <a:ext cx="69840" cy="7308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5199480" y="2246400"/>
              <a:ext cx="1297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Median maximum &gt;8000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1587600" y="1216080"/>
              <a:ext cx="0" cy="114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587600" y="1216080"/>
              <a:ext cx="253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854000" y="1216080"/>
              <a:ext cx="0" cy="168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535040" y="102096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3.8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 flipV="1">
              <a:off x="2565360" y="2016000"/>
              <a:ext cx="0" cy="11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565360" y="2016360"/>
              <a:ext cx="254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832120" y="2016360"/>
              <a:ext cx="0" cy="1168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513160" y="178308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4.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3543120" y="2828880"/>
              <a:ext cx="0" cy="11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3543120" y="2829240"/>
              <a:ext cx="254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3809880" y="2829240"/>
              <a:ext cx="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3490920" y="263376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2.4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4489560" y="3076560"/>
              <a:ext cx="0" cy="114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489560" y="3076920"/>
              <a:ext cx="2538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755960" y="3076920"/>
              <a:ext cx="0" cy="190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437000" y="2881440"/>
              <a:ext cx="37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</a:rPr>
                <a:t>1.4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09" name=""/>
          <p:cNvSpPr/>
          <p:nvPr/>
        </p:nvSpPr>
        <p:spPr>
          <a:xfrm>
            <a:off x="-3600" y="0"/>
            <a:ext cx="1366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 u="sng">
                <a:solidFill>
                  <a:srgbClr val="000000"/>
                </a:solidFill>
                <a:uFillTx/>
                <a:latin typeface="Times New Roman"/>
              </a:rPr>
              <a:t>Additional file 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269640" y="446040"/>
            <a:ext cx="40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404640" y="4019400"/>
            <a:ext cx="390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1633680" y="479736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0E-0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2573280" y="4797360"/>
            <a:ext cx="16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3392280" y="4797360"/>
            <a:ext cx="16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1633680" y="51768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.13E-2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2416320" y="51768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45E-0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3237120" y="51768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09E-0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1633680" y="56196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.61E-2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2378160" y="56196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92E-1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3237120" y="56196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7E-0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1633680" y="60498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2E-0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2378160" y="60498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23E-0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3237120" y="60498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10E-0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1684440" y="64674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96E-1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2378160" y="64674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81E-1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3237120" y="646740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.00E-0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1841400" y="6846840"/>
            <a:ext cx="16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2378160" y="6846840"/>
            <a:ext cx="473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.85E-0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3392280" y="6846840"/>
            <a:ext cx="162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NS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30" name=""/>
          <p:cNvGrpSpPr/>
          <p:nvPr/>
        </p:nvGrpSpPr>
        <p:grpSpPr>
          <a:xfrm>
            <a:off x="783000" y="4460760"/>
            <a:ext cx="2970000" cy="2651400"/>
            <a:chOff x="783000" y="4460760"/>
            <a:chExt cx="2970000" cy="2651400"/>
          </a:xfrm>
        </p:grpSpPr>
        <p:sp>
          <p:nvSpPr>
            <p:cNvPr id="131" name=""/>
            <p:cNvSpPr/>
            <p:nvPr/>
          </p:nvSpPr>
          <p:spPr>
            <a:xfrm>
              <a:off x="1711440" y="4473720"/>
              <a:ext cx="180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All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2518200" y="4473720"/>
              <a:ext cx="335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Short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387600" y="4460760"/>
              <a:ext cx="311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</a:rPr>
                <a:t>Long</a:t>
              </a:r>
              <a:endParaRPr b="0" lang="en-US" sz="11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34" name=""/>
            <p:cNvGrpSpPr/>
            <p:nvPr/>
          </p:nvGrpSpPr>
          <p:grpSpPr>
            <a:xfrm>
              <a:off x="784800" y="4700520"/>
              <a:ext cx="505080" cy="333000"/>
              <a:chOff x="784800" y="4700520"/>
              <a:chExt cx="505080" cy="333000"/>
            </a:xfrm>
          </p:grpSpPr>
          <p:sp>
            <p:nvSpPr>
              <p:cNvPr id="135" name=""/>
              <p:cNvSpPr/>
              <p:nvPr/>
            </p:nvSpPr>
            <p:spPr>
              <a:xfrm>
                <a:off x="785520" y="4700520"/>
                <a:ext cx="3877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784800" y="4865760"/>
                <a:ext cx="5050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-1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37" name=""/>
            <p:cNvGrpSpPr/>
            <p:nvPr/>
          </p:nvGrpSpPr>
          <p:grpSpPr>
            <a:xfrm>
              <a:off x="784800" y="5114880"/>
              <a:ext cx="505080" cy="332640"/>
              <a:chOff x="784800" y="5114880"/>
              <a:chExt cx="505080" cy="332640"/>
            </a:xfrm>
          </p:grpSpPr>
          <p:sp>
            <p:nvSpPr>
              <p:cNvPr id="138" name=""/>
              <p:cNvSpPr/>
              <p:nvPr/>
            </p:nvSpPr>
            <p:spPr>
              <a:xfrm>
                <a:off x="785520" y="5114880"/>
                <a:ext cx="3877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784800" y="5279760"/>
                <a:ext cx="5050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-2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40" name=""/>
            <p:cNvGrpSpPr/>
            <p:nvPr/>
          </p:nvGrpSpPr>
          <p:grpSpPr>
            <a:xfrm>
              <a:off x="783000" y="5530680"/>
              <a:ext cx="646920" cy="333000"/>
              <a:chOff x="783000" y="5530680"/>
              <a:chExt cx="646920" cy="333000"/>
            </a:xfrm>
          </p:grpSpPr>
          <p:sp>
            <p:nvSpPr>
              <p:cNvPr id="141" name=""/>
              <p:cNvSpPr/>
              <p:nvPr/>
            </p:nvSpPr>
            <p:spPr>
              <a:xfrm>
                <a:off x="785520" y="5530680"/>
                <a:ext cx="3877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783000" y="5695920"/>
                <a:ext cx="6469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-less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43" name=""/>
            <p:cNvGrpSpPr/>
            <p:nvPr/>
          </p:nvGrpSpPr>
          <p:grpSpPr>
            <a:xfrm>
              <a:off x="784800" y="5945040"/>
              <a:ext cx="505080" cy="332640"/>
              <a:chOff x="784800" y="5945040"/>
              <a:chExt cx="505080" cy="332640"/>
            </a:xfrm>
          </p:grpSpPr>
          <p:sp>
            <p:nvSpPr>
              <p:cNvPr id="144" name=""/>
              <p:cNvSpPr/>
              <p:nvPr/>
            </p:nvSpPr>
            <p:spPr>
              <a:xfrm>
                <a:off x="784800" y="5945040"/>
                <a:ext cx="5050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-1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784800" y="6109920"/>
                <a:ext cx="5050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-2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46" name=""/>
            <p:cNvGrpSpPr/>
            <p:nvPr/>
          </p:nvGrpSpPr>
          <p:grpSpPr>
            <a:xfrm>
              <a:off x="783000" y="6361200"/>
              <a:ext cx="646920" cy="331200"/>
              <a:chOff x="783000" y="6361200"/>
              <a:chExt cx="646920" cy="331200"/>
            </a:xfrm>
          </p:grpSpPr>
          <p:sp>
            <p:nvSpPr>
              <p:cNvPr id="147" name=""/>
              <p:cNvSpPr/>
              <p:nvPr/>
            </p:nvSpPr>
            <p:spPr>
              <a:xfrm>
                <a:off x="784800" y="6361200"/>
                <a:ext cx="5050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-1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783000" y="6524640"/>
                <a:ext cx="6469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-less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149" name=""/>
            <p:cNvGrpSpPr/>
            <p:nvPr/>
          </p:nvGrpSpPr>
          <p:grpSpPr>
            <a:xfrm>
              <a:off x="783000" y="6775560"/>
              <a:ext cx="646920" cy="330840"/>
              <a:chOff x="783000" y="6775560"/>
              <a:chExt cx="646920" cy="330840"/>
            </a:xfrm>
          </p:grpSpPr>
          <p:sp>
            <p:nvSpPr>
              <p:cNvPr id="150" name=""/>
              <p:cNvSpPr/>
              <p:nvPr/>
            </p:nvSpPr>
            <p:spPr>
              <a:xfrm>
                <a:off x="784800" y="6775560"/>
                <a:ext cx="5050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-2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783000" y="6938640"/>
                <a:ext cx="6469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Times New Roman"/>
                  </a:rPr>
                  <a:t>TATA-less</a:t>
                </a:r>
                <a:endParaRPr b="0" lang="en-US" sz="11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52" name=""/>
            <p:cNvSpPr/>
            <p:nvPr/>
          </p:nvSpPr>
          <p:spPr>
            <a:xfrm>
              <a:off x="787320" y="4622760"/>
              <a:ext cx="29656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1460520" y="4489560"/>
              <a:ext cx="0" cy="2622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17T10:42:59Z</dcterms:created>
  <dc:creator>Hesky Bialik</dc:creator>
  <dc:description/>
  <dc:language>en-US</dc:language>
  <cp:lastModifiedBy>Hesky Bialik</cp:lastModifiedBy>
  <dcterms:modified xsi:type="dcterms:W3CDTF">2008-02-25T11:23:49Z</dcterms:modified>
  <cp:revision>6</cp:revision>
  <dc:subject/>
  <dc:title>PowerPoint Presentation</dc:title>
</cp:coreProperties>
</file>